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2" r:id="rId4"/>
    <p:sldId id="263" r:id="rId5"/>
    <p:sldId id="264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1416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48691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1019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7574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67152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4910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5295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2184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3402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3299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450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40803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25816-A5EF-41E2-BADF-88D1B86D9A52}" type="datetimeFigureOut">
              <a:rPr lang="en-IN" smtClean="0"/>
              <a:pPr/>
              <a:t>20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A71D-47B1-4A41-A00C-C914D509485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44534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828" y="607798"/>
            <a:ext cx="2930172" cy="18306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620233"/>
            <a:ext cx="2895600" cy="18181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267200" y="1170801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ACT</a:t>
            </a:r>
            <a:endParaRPr lang="en-IN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2610596"/>
            <a:ext cx="2895600" cy="1809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4791802"/>
            <a:ext cx="2895600" cy="17613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2590801"/>
            <a:ext cx="2895600" cy="1809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5943600" y="30480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272147" y="3149025"/>
            <a:ext cx="60465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CAC</a:t>
            </a:r>
          </a:p>
          <a:p>
            <a:endParaRPr lang="en-US" sz="1600" dirty="0">
              <a:solidFill>
                <a:srgbClr val="7030A0"/>
              </a:solidFill>
            </a:endParaRPr>
          </a:p>
        </p:txBody>
      </p:sp>
      <p:pic>
        <p:nvPicPr>
          <p:cNvPr id="17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4800600"/>
            <a:ext cx="2895600" cy="1752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4309760" y="5361801"/>
            <a:ext cx="59343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GAP</a:t>
            </a:r>
            <a:endParaRPr lang="en-IN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486400" y="1524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getative &amp; Reproductive stage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066800" y="149423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iotic stress treatment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7935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457200"/>
            <a:ext cx="2895600" cy="1809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2514600"/>
            <a:ext cx="2895600" cy="1809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2514600"/>
            <a:ext cx="2895600" cy="1809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Rectangle 16"/>
          <p:cNvSpPr/>
          <p:nvPr/>
        </p:nvSpPr>
        <p:spPr>
          <a:xfrm>
            <a:off x="4343400" y="2999601"/>
            <a:ext cx="5822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CYP</a:t>
            </a:r>
            <a:endParaRPr lang="en-IN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381000"/>
            <a:ext cx="2895600" cy="1809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Rectangle 12"/>
          <p:cNvSpPr/>
          <p:nvPr/>
        </p:nvSpPr>
        <p:spPr>
          <a:xfrm>
            <a:off x="4256976" y="1170801"/>
            <a:ext cx="86754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SAMDc</a:t>
            </a:r>
            <a:endParaRPr lang="en-US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4724401"/>
            <a:ext cx="2895600" cy="1828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4724400"/>
            <a:ext cx="2895600" cy="182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Rectangle 20"/>
          <p:cNvSpPr/>
          <p:nvPr/>
        </p:nvSpPr>
        <p:spPr>
          <a:xfrm>
            <a:off x="4343400" y="4953000"/>
            <a:ext cx="50366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18S</a:t>
            </a:r>
            <a:endParaRPr lang="en-IN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066800" y="762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iotic stress treatment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486400" y="1524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getative &amp; Reproductive stage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4008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90601" y="381001"/>
            <a:ext cx="2895599" cy="18287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334000" y="400797"/>
            <a:ext cx="2895600" cy="18090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Rectangle 7"/>
          <p:cNvSpPr/>
          <p:nvPr/>
        </p:nvSpPr>
        <p:spPr>
          <a:xfrm>
            <a:off x="4346334" y="838200"/>
            <a:ext cx="64460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RCA </a:t>
            </a:r>
            <a:endParaRPr lang="en-GB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990601" y="2438400"/>
            <a:ext cx="2895599" cy="18090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334001" y="2438400"/>
            <a:ext cx="2895599" cy="18090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Rectangle 12"/>
          <p:cNvSpPr/>
          <p:nvPr/>
        </p:nvSpPr>
        <p:spPr>
          <a:xfrm>
            <a:off x="4343400" y="2847201"/>
            <a:ext cx="63511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FtsH</a:t>
            </a:r>
            <a:r>
              <a:rPr lang="en-US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2000" y="4495800"/>
            <a:ext cx="3124200" cy="1951820"/>
          </a:xfrm>
          <a:prstGeom prst="rect">
            <a:avLst/>
          </a:prstGeom>
          <a:ln w="317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29200" y="4495800"/>
            <a:ext cx="3352800" cy="1904214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4267200" y="4953000"/>
            <a:ext cx="70243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EF1-</a:t>
            </a:r>
            <a:r>
              <a:rPr lang="el-GR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α</a:t>
            </a:r>
            <a:endParaRPr lang="en-US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066800" y="762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iotic stress treatment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86400" y="73223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getative &amp; Reproductive stage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98055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401108"/>
            <a:ext cx="2895600" cy="15800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9200" y="457199"/>
            <a:ext cx="2895600" cy="160020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031697" y="713601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ETIF3E</a:t>
            </a:r>
            <a:endParaRPr lang="en-US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800" y="2420018"/>
            <a:ext cx="2895600" cy="161858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29200" y="2391423"/>
            <a:ext cx="2895600" cy="1570977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062039" y="2999601"/>
            <a:ext cx="6623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PP2A</a:t>
            </a:r>
            <a:endParaRPr lang="en-US" sz="1600" dirty="0">
              <a:solidFill>
                <a:srgbClr val="7030A0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5800" y="4429813"/>
            <a:ext cx="2895600" cy="166618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29200" y="4448823"/>
            <a:ext cx="2895600" cy="1570977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4038600" y="4904601"/>
            <a:ext cx="7697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600" dirty="0" smtClean="0">
                <a:solidFill>
                  <a:srgbClr val="7030A0"/>
                </a:solidFill>
                <a:latin typeface="Times New Roman" pitchFamily="18" charset="0"/>
                <a:cs typeface="Times New Roman" pitchFamily="18" charset="0"/>
              </a:rPr>
              <a:t>-TUB</a:t>
            </a:r>
            <a:endParaRPr lang="en-US" sz="1600" dirty="0">
              <a:solidFill>
                <a:srgbClr val="7030A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6800" y="149423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iotic stress treatment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57800" y="762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getative &amp; Reproductive stage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85801"/>
            <a:ext cx="2971800" cy="167639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6800" y="685800"/>
            <a:ext cx="2971800" cy="1676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886200" y="1295401"/>
            <a:ext cx="990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600" dirty="0" smtClean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TUB</a:t>
            </a:r>
            <a:endParaRPr lang="en-US" sz="16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66800" y="225623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iotic stress treatment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105400" y="2286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getative &amp; Reproductive stages</a:t>
            </a:r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51</Words>
  <Application>Microsoft Office PowerPoint</Application>
  <PresentationFormat>On-screen Show (4:3)</PresentationFormat>
  <Paragraphs>2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awt</cp:lastModifiedBy>
  <cp:revision>80</cp:revision>
  <dcterms:created xsi:type="dcterms:W3CDTF">2017-03-14T09:02:23Z</dcterms:created>
  <dcterms:modified xsi:type="dcterms:W3CDTF">2017-03-20T04:37:37Z</dcterms:modified>
</cp:coreProperties>
</file>